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6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3" d="100"/>
          <a:sy n="73" d="100"/>
        </p:scale>
        <p:origin x="30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tt Lanktree" userId="b42c2f6b0dfd1fab" providerId="LiveId" clId="{A9F8561E-88E0-449C-8772-CAEE2AA8A9C2}"/>
    <pc:docChg chg="undo custSel addSld modSld sldOrd">
      <pc:chgData name="Matt Lanktree" userId="b42c2f6b0dfd1fab" providerId="LiveId" clId="{A9F8561E-88E0-449C-8772-CAEE2AA8A9C2}" dt="2021-09-03T20:31:28.467" v="403" actId="20577"/>
      <pc:docMkLst>
        <pc:docMk/>
      </pc:docMkLst>
      <pc:sldChg chg="addSp modSp mod ord">
        <pc:chgData name="Matt Lanktree" userId="b42c2f6b0dfd1fab" providerId="LiveId" clId="{A9F8561E-88E0-449C-8772-CAEE2AA8A9C2}" dt="2021-09-03T20:31:11.959" v="400" actId="1076"/>
        <pc:sldMkLst>
          <pc:docMk/>
          <pc:sldMk cId="1625583189" sldId="256"/>
        </pc:sldMkLst>
        <pc:spChg chg="add mod">
          <ac:chgData name="Matt Lanktree" userId="b42c2f6b0dfd1fab" providerId="LiveId" clId="{A9F8561E-88E0-449C-8772-CAEE2AA8A9C2}" dt="2021-09-03T20:31:11.959" v="400" actId="1076"/>
          <ac:spMkLst>
            <pc:docMk/>
            <pc:sldMk cId="1625583189" sldId="256"/>
            <ac:spMk id="3" creationId="{EC73431F-067F-482A-86BA-EB65A8ED40AD}"/>
          </ac:spMkLst>
        </pc:spChg>
      </pc:sldChg>
      <pc:sldChg chg="addSp modSp mod">
        <pc:chgData name="Matt Lanktree" userId="b42c2f6b0dfd1fab" providerId="LiveId" clId="{A9F8561E-88E0-449C-8772-CAEE2AA8A9C2}" dt="2021-09-03T20:31:23.149" v="402" actId="20577"/>
        <pc:sldMkLst>
          <pc:docMk/>
          <pc:sldMk cId="3624095548" sldId="257"/>
        </pc:sldMkLst>
        <pc:spChg chg="add mod">
          <ac:chgData name="Matt Lanktree" userId="b42c2f6b0dfd1fab" providerId="LiveId" clId="{A9F8561E-88E0-449C-8772-CAEE2AA8A9C2}" dt="2021-09-03T20:31:23.149" v="402" actId="20577"/>
          <ac:spMkLst>
            <pc:docMk/>
            <pc:sldMk cId="3624095548" sldId="257"/>
            <ac:spMk id="5" creationId="{C67D0EAF-A75C-45F2-BD43-3D0CE38A00C6}"/>
          </ac:spMkLst>
        </pc:spChg>
        <pc:picChg chg="add mod">
          <ac:chgData name="Matt Lanktree" userId="b42c2f6b0dfd1fab" providerId="LiveId" clId="{A9F8561E-88E0-449C-8772-CAEE2AA8A9C2}" dt="2021-09-03T20:24:17.092" v="7" actId="1076"/>
          <ac:picMkLst>
            <pc:docMk/>
            <pc:sldMk cId="3624095548" sldId="257"/>
            <ac:picMk id="2" creationId="{F94D0A42-A2B9-3C46-838E-CEFCB09E0168}"/>
          </ac:picMkLst>
        </pc:picChg>
        <pc:picChg chg="add mod">
          <ac:chgData name="Matt Lanktree" userId="b42c2f6b0dfd1fab" providerId="LiveId" clId="{A9F8561E-88E0-449C-8772-CAEE2AA8A9C2}" dt="2021-09-03T20:24:17.092" v="7" actId="1076"/>
          <ac:picMkLst>
            <pc:docMk/>
            <pc:sldMk cId="3624095548" sldId="257"/>
            <ac:picMk id="3" creationId="{C59E2228-5334-464D-86CA-2BA87945B683}"/>
          </ac:picMkLst>
        </pc:picChg>
        <pc:picChg chg="add mod">
          <ac:chgData name="Matt Lanktree" userId="b42c2f6b0dfd1fab" providerId="LiveId" clId="{A9F8561E-88E0-449C-8772-CAEE2AA8A9C2}" dt="2021-09-03T20:24:17.092" v="7" actId="1076"/>
          <ac:picMkLst>
            <pc:docMk/>
            <pc:sldMk cId="3624095548" sldId="257"/>
            <ac:picMk id="4" creationId="{3C88139C-0115-9647-8A3D-A1AB16511DE8}"/>
          </ac:picMkLst>
        </pc:picChg>
      </pc:sldChg>
      <pc:sldChg chg="addSp modSp new mod">
        <pc:chgData name="Matt Lanktree" userId="b42c2f6b0dfd1fab" providerId="LiveId" clId="{A9F8561E-88E0-449C-8772-CAEE2AA8A9C2}" dt="2021-09-03T20:31:28.467" v="403" actId="20577"/>
        <pc:sldMkLst>
          <pc:docMk/>
          <pc:sldMk cId="75252614" sldId="258"/>
        </pc:sldMkLst>
        <pc:spChg chg="add mod">
          <ac:chgData name="Matt Lanktree" userId="b42c2f6b0dfd1fab" providerId="LiveId" clId="{A9F8561E-88E0-449C-8772-CAEE2AA8A9C2}" dt="2021-09-03T20:31:28.467" v="403" actId="20577"/>
          <ac:spMkLst>
            <pc:docMk/>
            <pc:sldMk cId="75252614" sldId="258"/>
            <ac:spMk id="3" creationId="{28992FCD-3971-4EA4-AE4C-B76A6E6AECEA}"/>
          </ac:spMkLst>
        </pc:spChg>
        <pc:picChg chg="add mod">
          <ac:chgData name="Matt Lanktree" userId="b42c2f6b0dfd1fab" providerId="LiveId" clId="{A9F8561E-88E0-449C-8772-CAEE2AA8A9C2}" dt="2021-09-03T20:28:21.815" v="238" actId="1076"/>
          <ac:picMkLst>
            <pc:docMk/>
            <pc:sldMk cId="75252614" sldId="258"/>
            <ac:picMk id="2" creationId="{9A25C5BB-6E19-FA4A-94AC-1C3A8C4EAC12}"/>
          </ac:picMkLst>
        </pc:picChg>
      </pc:sldChg>
    </pc:docChg>
  </pc:docChgLst>
  <pc:docChgLst>
    <pc:chgData name="Matt Lanktree" userId="b42c2f6b0dfd1fab" providerId="LiveId" clId="{235E07EA-1405-4186-B979-EF6088FA451A}"/>
    <pc:docChg chg="modSld">
      <pc:chgData name="Matt Lanktree" userId="b42c2f6b0dfd1fab" providerId="LiveId" clId="{235E07EA-1405-4186-B979-EF6088FA451A}" dt="2021-10-07T18:03:04.751" v="39" actId="20577"/>
      <pc:docMkLst>
        <pc:docMk/>
      </pc:docMkLst>
      <pc:sldChg chg="modSp mod">
        <pc:chgData name="Matt Lanktree" userId="b42c2f6b0dfd1fab" providerId="LiveId" clId="{235E07EA-1405-4186-B979-EF6088FA451A}" dt="2021-10-07T18:03:04.751" v="39" actId="20577"/>
        <pc:sldMkLst>
          <pc:docMk/>
          <pc:sldMk cId="1625583189" sldId="256"/>
        </pc:sldMkLst>
        <pc:spChg chg="mod">
          <ac:chgData name="Matt Lanktree" userId="b42c2f6b0dfd1fab" providerId="LiveId" clId="{235E07EA-1405-4186-B979-EF6088FA451A}" dt="2021-10-07T18:03:04.751" v="39" actId="20577"/>
          <ac:spMkLst>
            <pc:docMk/>
            <pc:sldMk cId="1625583189" sldId="256"/>
            <ac:spMk id="3" creationId="{EC73431F-067F-482A-86BA-EB65A8ED40AD}"/>
          </ac:spMkLst>
        </pc:spChg>
      </pc:sldChg>
      <pc:sldChg chg="modSp mod">
        <pc:chgData name="Matt Lanktree" userId="b42c2f6b0dfd1fab" providerId="LiveId" clId="{235E07EA-1405-4186-B979-EF6088FA451A}" dt="2021-10-07T18:02:00.446" v="33" actId="20577"/>
        <pc:sldMkLst>
          <pc:docMk/>
          <pc:sldMk cId="3624095548" sldId="257"/>
        </pc:sldMkLst>
        <pc:spChg chg="mod">
          <ac:chgData name="Matt Lanktree" userId="b42c2f6b0dfd1fab" providerId="LiveId" clId="{235E07EA-1405-4186-B979-EF6088FA451A}" dt="2021-10-07T18:02:00.446" v="33" actId="20577"/>
          <ac:spMkLst>
            <pc:docMk/>
            <pc:sldMk cId="3624095548" sldId="257"/>
            <ac:spMk id="5" creationId="{C67D0EAF-A75C-45F2-BD43-3D0CE38A00C6}"/>
          </ac:spMkLst>
        </pc:spChg>
      </pc:sldChg>
      <pc:sldChg chg="modSp mod">
        <pc:chgData name="Matt Lanktree" userId="b42c2f6b0dfd1fab" providerId="LiveId" clId="{235E07EA-1405-4186-B979-EF6088FA451A}" dt="2021-10-07T18:02:19.478" v="37" actId="6549"/>
        <pc:sldMkLst>
          <pc:docMk/>
          <pc:sldMk cId="75252614" sldId="258"/>
        </pc:sldMkLst>
        <pc:spChg chg="mod">
          <ac:chgData name="Matt Lanktree" userId="b42c2f6b0dfd1fab" providerId="LiveId" clId="{235E07EA-1405-4186-B979-EF6088FA451A}" dt="2021-10-07T18:02:19.478" v="37" actId="6549"/>
          <ac:spMkLst>
            <pc:docMk/>
            <pc:sldMk cId="75252614" sldId="258"/>
            <ac:spMk id="3" creationId="{28992FCD-3971-4EA4-AE4C-B76A6E6AECEA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26419C-BE17-4FC4-8E2F-4D5FF0FCCF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0E6E26B-BA8E-4ACA-8ACA-D513CCF16FA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62FD2B-C156-40EA-9AD4-719C6E3889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E4A83-960C-45BA-B24F-DB84A133EE5D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C405BF-1932-40B9-A6C0-C62F8F6CDB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8F7F40-3CF2-499F-AAD8-12035E342A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8472D-DD84-419B-8523-A409597E87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48249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B52D8F-7337-4AA7-BBEE-ED42719F19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6841E8-A4CD-40B1-87F3-08A93CFC62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75631B-3B89-4F58-8A0C-4AE22243C2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E4A83-960C-45BA-B24F-DB84A133EE5D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7866B9-FF99-467B-9C65-0B0E610797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591B6A-0750-4208-9EC6-A2684A77A7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8472D-DD84-419B-8523-A409597E87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95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D75CBAA-D56A-4973-8FB3-4CD5746A7B0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5340802-83E1-487A-BC5F-FD4C62DB49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7A816B-1CCE-42E3-88E1-ECABD2BC02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E4A83-960C-45BA-B24F-DB84A133EE5D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FE0751-389B-4158-8A2F-8014310155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56E5BA-0376-4F93-9EB7-2F8B8E71C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8472D-DD84-419B-8523-A409597E87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704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BD916C-7533-46A0-ADAF-86DB31D86E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454A9C-EBE8-46E7-B654-E3B98B77C3E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DEA768-E26F-4CEA-AFA5-74F3AE487A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E4A83-960C-45BA-B24F-DB84A133EE5D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B38615-09C2-48D0-A09B-A64F08E94B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854508-8FDA-4D60-88B8-A1B0CFDAC2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8472D-DD84-419B-8523-A409597E87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5787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EBBCFF-007C-41E1-B350-7EBD1ADE18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EF0F86-C773-449C-BC4A-A87C38C1C0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3F4F04-7CC4-4920-ABFC-5495C894B6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E4A83-960C-45BA-B24F-DB84A133EE5D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302C85-2A32-413D-A638-D86D8FD829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8BCB96-AFA8-49BE-BE7F-A0D92B8534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8472D-DD84-419B-8523-A409597E87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52219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41B7DF-5C39-43BE-897C-2E81C3F4C8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40CD15-300C-4A5D-938A-30DB0BCF3C5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6BF89A7-D454-4898-AA0A-C209B90FF3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5ADA44-6B80-42B1-8071-83F1852758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E4A83-960C-45BA-B24F-DB84A133EE5D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7636DF-0DA9-4218-A513-E4F52DE9C1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FA714F-ED58-47B9-B462-F3DBF02134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8472D-DD84-419B-8523-A409597E87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28772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4798EC-CE24-42D0-84D5-EFF76EC8E4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8A0FF7-A1DE-438D-9A88-ADEAB9800E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090E2F6-DB5E-497A-AD16-6A0EE18219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EE2C759-53FA-4AAB-B609-E37F17EFBF6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27E375C-28A2-4C78-AA52-F20842755CA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1791DAE-FD8C-4DB1-ACA1-D0FD50949D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E4A83-960C-45BA-B24F-DB84A133EE5D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A007FB6-E11D-4BB8-9C94-0EA2AAD9E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1144917-CEC2-4F73-8691-A28CA8D18D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8472D-DD84-419B-8523-A409597E87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61523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B4144F-1F4D-473F-880A-94D31466CD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870E90E-CC5C-43BD-B24B-D378BA00AF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E4A83-960C-45BA-B24F-DB84A133EE5D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E41B15F-9017-4A37-9389-CA50D72E01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6011A18-353F-4FB4-B5D6-5E788673BC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8472D-DD84-419B-8523-A409597E87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06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33A15AF-A9F3-4502-ABEB-D237905BE1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E4A83-960C-45BA-B24F-DB84A133EE5D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6425CE0-5C90-4800-BECD-9ADBAA6600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B462965-5B7E-4D4A-B0A7-B2097DC04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8472D-DD84-419B-8523-A409597E87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5789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EF389-242B-4DA2-8845-9503E6BCB5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68C843-4179-4208-8CD3-3A80B6DC192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F8A7508-17CB-4952-9EDA-938721376E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99136A-E769-479E-B21B-664234C32D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E4A83-960C-45BA-B24F-DB84A133EE5D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C24F1B-3A95-45D2-A0F3-8E0D5A3D31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7137728-FE85-44A4-AB08-AA39D57222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8472D-DD84-419B-8523-A409597E87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731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3DEBBA-FDA3-47F3-8C58-F4812ED2BA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09140AB-0197-48FE-A1F7-32CA55831FF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111802-FE8A-4433-9451-2DCBDF4934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B1D29C-F3E3-4AB9-8A9C-A86F94DF0D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E4A83-960C-45BA-B24F-DB84A133EE5D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2128CE-0B30-40A9-83E5-BE66210E20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D5DB41-369F-40FD-9D02-4CABAD9569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8472D-DD84-419B-8523-A409597E87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17850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50728A0-1DFA-4F2F-8713-E13B073A34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25E6FA-C7D0-44CD-88FB-8D5346D082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C650FB-ACFF-4048-9D47-41CC042B8E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3E4A83-960C-45BA-B24F-DB84A133EE5D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B029AF-7020-4F2F-ADBE-5D58B60D1C5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1063F8-772D-435E-927A-BAE1550C850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18472D-DD84-419B-8523-A409597E87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352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94D0A42-A2B9-3C46-838E-CEFCB09E016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959" y="608441"/>
            <a:ext cx="3719002" cy="448663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59E2228-5334-464D-86CA-2BA87945B68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66071" y="562333"/>
            <a:ext cx="3702107" cy="446479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3C88139C-0115-9647-8A3D-A1AB16511DE8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3134" y="562333"/>
            <a:ext cx="3707764" cy="453274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67D0EAF-A75C-45F2-BD43-3D0CE38A00C6}"/>
              </a:ext>
            </a:extLst>
          </p:cNvPr>
          <p:cNvSpPr txBox="1"/>
          <p:nvPr/>
        </p:nvSpPr>
        <p:spPr>
          <a:xfrm>
            <a:off x="865239" y="5555226"/>
            <a:ext cx="106385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1. </a:t>
            </a:r>
            <a:r>
              <a:rPr lang="en-US" dirty="0"/>
              <a:t>Two sample Mendelian randomization plots of the instrument effect on </a:t>
            </a:r>
            <a:r>
              <a:rPr lang="en-US" i="1" dirty="0"/>
              <a:t>ACLY </a:t>
            </a:r>
            <a:r>
              <a:rPr lang="en-US" dirty="0"/>
              <a:t>expression and risk of CKD (A), Urine ACR (B), and eGFR (C) in </a:t>
            </a:r>
            <a:r>
              <a:rPr lang="en-US" dirty="0" err="1"/>
              <a:t>CKDGen</a:t>
            </a:r>
            <a:r>
              <a:rPr lang="en-US" dirty="0"/>
              <a:t>. </a:t>
            </a:r>
            <a:endParaRPr lang="en-CA" b="1" i="1" dirty="0"/>
          </a:p>
        </p:txBody>
      </p:sp>
    </p:spTree>
    <p:extLst>
      <p:ext uri="{BB962C8B-B14F-4D97-AF65-F5344CB8AC3E}">
        <p14:creationId xmlns:p14="http://schemas.microsoft.com/office/powerpoint/2010/main" val="36240955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A25C5BB-6E19-FA4A-94AC-1C3A8C4EAC1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1720" y="584351"/>
            <a:ext cx="4188247" cy="521222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8992FCD-3971-4EA4-AE4C-B76A6E6AECEA}"/>
              </a:ext>
            </a:extLst>
          </p:cNvPr>
          <p:cNvSpPr txBox="1"/>
          <p:nvPr/>
        </p:nvSpPr>
        <p:spPr>
          <a:xfrm>
            <a:off x="5566728" y="2415209"/>
            <a:ext cx="608221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2. </a:t>
            </a:r>
            <a:r>
              <a:rPr lang="en-US" dirty="0"/>
              <a:t>Two sample Mendelian randomization plots of the instrument effect on </a:t>
            </a:r>
            <a:r>
              <a:rPr lang="en-US" i="1" dirty="0"/>
              <a:t>ACLY </a:t>
            </a:r>
            <a:r>
              <a:rPr lang="en-US" dirty="0"/>
              <a:t>expression and risk of CKD in </a:t>
            </a:r>
            <a:r>
              <a:rPr lang="en-US" dirty="0" err="1"/>
              <a:t>FinnGen</a:t>
            </a:r>
            <a:r>
              <a:rPr lang="en-US" dirty="0"/>
              <a:t>. </a:t>
            </a:r>
            <a:endParaRPr lang="en-CA" b="1" i="1" dirty="0"/>
          </a:p>
        </p:txBody>
      </p:sp>
    </p:spTree>
    <p:extLst>
      <p:ext uri="{BB962C8B-B14F-4D97-AF65-F5344CB8AC3E}">
        <p14:creationId xmlns:p14="http://schemas.microsoft.com/office/powerpoint/2010/main" val="752526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34F3414-59C6-47FF-89C9-E10FE6A3E3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7896" y="893621"/>
            <a:ext cx="11416208" cy="403348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C73431F-067F-482A-86BA-EB65A8ED40AD}"/>
              </a:ext>
            </a:extLst>
          </p:cNvPr>
          <p:cNvSpPr txBox="1"/>
          <p:nvPr/>
        </p:nvSpPr>
        <p:spPr>
          <a:xfrm>
            <a:off x="776748" y="4927107"/>
            <a:ext cx="106385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/>
              <a:t>Figure S3</a:t>
            </a:r>
            <a:r>
              <a:rPr lang="en-US" b="1" dirty="0"/>
              <a:t>. </a:t>
            </a:r>
            <a:r>
              <a:rPr lang="en-US" dirty="0" err="1"/>
              <a:t>GTEx</a:t>
            </a:r>
            <a:r>
              <a:rPr lang="en-US" dirty="0"/>
              <a:t> tissue-specific expression of </a:t>
            </a:r>
            <a:r>
              <a:rPr lang="en-US" i="1" dirty="0"/>
              <a:t>SLC27A2 </a:t>
            </a:r>
            <a:r>
              <a:rPr lang="en-US" dirty="0"/>
              <a:t>which is required for the activation of </a:t>
            </a:r>
            <a:r>
              <a:rPr lang="en-US" dirty="0" err="1"/>
              <a:t>bempedoic</a:t>
            </a:r>
            <a:r>
              <a:rPr lang="en-US" dirty="0"/>
              <a:t> acid. </a:t>
            </a:r>
            <a:endParaRPr lang="en-CA" b="1" i="1" dirty="0"/>
          </a:p>
        </p:txBody>
      </p:sp>
    </p:spTree>
    <p:extLst>
      <p:ext uri="{BB962C8B-B14F-4D97-AF65-F5344CB8AC3E}">
        <p14:creationId xmlns:p14="http://schemas.microsoft.com/office/powerpoint/2010/main" val="16255831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</TotalTime>
  <Words>75</Words>
  <Application>Microsoft Office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nktree, Matthew</dc:creator>
  <cp:lastModifiedBy>Matt Lanktree</cp:lastModifiedBy>
  <cp:revision>2</cp:revision>
  <dcterms:created xsi:type="dcterms:W3CDTF">2021-09-02T18:22:48Z</dcterms:created>
  <dcterms:modified xsi:type="dcterms:W3CDTF">2021-10-07T18:03:19Z</dcterms:modified>
</cp:coreProperties>
</file>